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732" y="8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66C87E0-E306-4E79-9B4B-99D3460BE0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E418A42-EABD-4DE1-B0A2-DAC2D42485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E3C0FC2-0A31-4C89-943F-2D7DCC155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6EE4631-EEEC-438F-A241-845584AB4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B7A5603-7BFD-4E28-B0AE-9F01B498F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516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4F2A4B5-23CD-4EE3-9426-91EE1E6AFF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D4DC3A0-CFA2-4F66-AAA4-B966D71593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F79195-8082-4866-8A03-325679306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464220B-E636-4B0C-A01E-9B53DBC82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8C2A46-38AA-426C-AB6D-89E49953E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833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47956DC-CDF8-4BB6-9144-AAE8C2418E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EFA6B49-11D7-4D7F-BD91-6E3E725EC8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DEA3E0A-E5D9-4519-B958-EBE970AB2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602787E-81B6-42AC-A640-E704352F7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9AA907D-0361-460D-97B8-9F0ACFE1D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672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C7FD53-53CE-44D3-90F6-B7C02CFD6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AD2EF35-F8F9-44A7-ADDE-DB0B3FED48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09404BF-4A73-4077-B2A6-99473369D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7343294-DC85-4B53-B21C-2C47963A6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EA61D5E-3979-4ADF-9FE9-9D380A313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75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63F9BC5-AC6C-4F8E-BEF1-BB246A570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4CDB430-E626-4A57-A7CA-B6395C008F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A9FC6FA-5CAD-4E85-AD92-A7A7C72C9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B1BFE73-F423-4CF8-B96C-A1984BBE9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2BBE37B-D8B3-4A20-983A-C555556E3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871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7C8E67-A811-4507-B58B-0F1173F7C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0473B97-0BD8-4228-A9A4-C46585ED2A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A0F7D0F-DFF4-46D7-B09A-1385318041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3C632BF-9D84-4555-A2B6-AE76CB359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1257FF9-F5F8-438D-8219-0151DD313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089750-F4B4-459B-84B0-C99FA4D76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917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F800A6-1701-48A3-9158-292AF5A92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92A928F-2B05-43E8-8192-A090EA93E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7062844-6256-4D0F-BDBC-E4E1FDBA77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73B1DBF-F55A-4EBD-A15B-1A5256F86F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B02C362-FEB7-476A-9F06-5B01CD4E4A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3C37FF2-19B5-4E8A-BB05-A443F5661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1F2A507-F12F-47D8-BCD4-D54E99490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FABFD42-15F2-4F70-AF99-0B224B61B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666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E66B3B7-3CDA-4561-A6E1-02DA2CB3E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643CC96-1EBE-41C8-89F5-13B9D34F1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8B6F34F-B0AA-423D-9ECE-8ECB2B0E7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CA339D0-933E-493B-A0F2-6575D0807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33EE8C6-E12D-41B2-A686-4EB096253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64BFBA3-E83B-4208-B9DD-420BA59A1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DFB0150-7855-4DC6-A07F-FF286DAE4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608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7D8E4D-18A5-46A5-AF85-5192ABD95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D80CCA3-7820-4687-AFCD-CD97501F00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5C3020B-B1E9-437B-ADFA-53143DBD0B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BE3A3D6-303B-4049-AF9F-095E6ABC6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E24FC13-1674-4894-9C32-890F29D81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DED78F2-DF8F-49BB-810B-E7FC2FC01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75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3384047-0B7D-4AB3-9F2B-DB2DAF58E4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D87B8E4-F0DB-4FC6-A528-609E577883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B50BB76-F0F8-4683-8C6F-A918395BCE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7B15794-E99F-4E1B-AB3F-43C1EA084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E468154-9C44-4F18-8CC1-F7696B9DD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AE482BD-7969-4DE0-99B9-927032877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908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811282E-281A-4DF7-B3B4-6D5359CC9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E7B5C51-7D2E-4461-B76B-9499A1F782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651AE55-BE12-4F5A-9A45-3ECA8EF71B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571D4-80F5-471D-BD63-48A5C3D917E0}" type="datetimeFigureOut">
              <a:rPr lang="en-US" smtClean="0"/>
              <a:t>4/24/2025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C7E80F-D940-408C-875A-DB9734C77C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1F8EF11-F622-4A51-96BB-EE74BAD0E0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EC5AE-E286-4FA4-8787-F0C346FF492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23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E7214811-E006-435C-BFB0-840EA46260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2317" y="590706"/>
            <a:ext cx="9367367" cy="6265867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35933C2F-699E-4382-B631-0CA0377973EE}"/>
              </a:ext>
            </a:extLst>
          </p:cNvPr>
          <p:cNvSpPr txBox="1"/>
          <p:nvPr/>
        </p:nvSpPr>
        <p:spPr>
          <a:xfrm>
            <a:off x="732711" y="96892"/>
            <a:ext cx="100283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e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biome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 (n = 30) with minimum prevalence level of 20% and minimum abundance of 0.01% in all samples. Red to blue shades represent increase abundance. 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14600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5</cp:revision>
  <dcterms:created xsi:type="dcterms:W3CDTF">2025-03-20T13:46:52Z</dcterms:created>
  <dcterms:modified xsi:type="dcterms:W3CDTF">2025-04-24T15:13:27Z</dcterms:modified>
</cp:coreProperties>
</file>